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96" r:id="rId2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="" xmlns:p14="http://schemas.microsoft.com/office/powerpoint/2010/main">
          <a:srgbClr val="FF0000"/>
        </p14:laserClr>
      </p:ext>
      <p:ext uri="{2FDB2607-1784-4EEB-B798-7EB5836EED8A}">
        <p14:showMediaCtrls xmlns="" xmlns:p14="http://schemas.microsoft.com/office/powerpoint/2010/main" val="1"/>
      </p:ext>
    </p:extLst>
  </p:showPr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79294" autoAdjust="0"/>
  </p:normalViewPr>
  <p:slideViewPr>
    <p:cSldViewPr>
      <p:cViewPr>
        <p:scale>
          <a:sx n="91" d="100"/>
          <a:sy n="91" d="100"/>
        </p:scale>
        <p:origin x="-1210" y="51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1FCEF4E-2DD9-4CDE-A225-EE49372CFCCD}" type="datetimeFigureOut">
              <a:rPr lang="ko-KR" altLang="en-US" smtClean="0"/>
              <a:pPr/>
              <a:t>2022-06-07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5447953-45FE-4FD3-85D8-667E69F9041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="" xmlns:p14="http://schemas.microsoft.com/office/powerpoint/2010/main" val="297853065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/>
              <a:t>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353C6-D15F-410C-90A8-B8EFFAAFDC54}" type="datetimeFigureOut">
              <a:rPr lang="ko-KR" altLang="en-US" smtClean="0"/>
              <a:pPr/>
              <a:t>2022-06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9C386B-4784-4080-93BF-55B8687F13E4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="" xmlns:p14="http://schemas.microsoft.com/office/powerpoint/2010/main" val="30006358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353C6-D15F-410C-90A8-B8EFFAAFDC54}" type="datetimeFigureOut">
              <a:rPr lang="ko-KR" altLang="en-US" smtClean="0"/>
              <a:pPr/>
              <a:t>2022-06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9C386B-4784-4080-93BF-55B8687F13E4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="" xmlns:p14="http://schemas.microsoft.com/office/powerpoint/2010/main" val="7136545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353C6-D15F-410C-90A8-B8EFFAAFDC54}" type="datetimeFigureOut">
              <a:rPr lang="ko-KR" altLang="en-US" smtClean="0"/>
              <a:pPr/>
              <a:t>2022-06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9C386B-4784-4080-93BF-55B8687F13E4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="" xmlns:p14="http://schemas.microsoft.com/office/powerpoint/2010/main" val="41860227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353C6-D15F-410C-90A8-B8EFFAAFDC54}" type="datetimeFigureOut">
              <a:rPr lang="ko-KR" altLang="en-US" smtClean="0"/>
              <a:pPr/>
              <a:t>2022-06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9C386B-4784-4080-93BF-55B8687F13E4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="" xmlns:p14="http://schemas.microsoft.com/office/powerpoint/2010/main" val="9366515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353C6-D15F-410C-90A8-B8EFFAAFDC54}" type="datetimeFigureOut">
              <a:rPr lang="ko-KR" altLang="en-US" smtClean="0"/>
              <a:pPr/>
              <a:t>2022-06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9C386B-4784-4080-93BF-55B8687F13E4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="" xmlns:p14="http://schemas.microsoft.com/office/powerpoint/2010/main" val="20943150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353C6-D15F-410C-90A8-B8EFFAAFDC54}" type="datetimeFigureOut">
              <a:rPr lang="ko-KR" altLang="en-US" smtClean="0"/>
              <a:pPr/>
              <a:t>2022-06-0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9C386B-4784-4080-93BF-55B8687F13E4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="" xmlns:p14="http://schemas.microsoft.com/office/powerpoint/2010/main" val="2033343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353C6-D15F-410C-90A8-B8EFFAAFDC54}" type="datetimeFigureOut">
              <a:rPr lang="ko-KR" altLang="en-US" smtClean="0"/>
              <a:pPr/>
              <a:t>2022-06-07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9C386B-4784-4080-93BF-55B8687F13E4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="" xmlns:p14="http://schemas.microsoft.com/office/powerpoint/2010/main" val="37302697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353C6-D15F-410C-90A8-B8EFFAAFDC54}" type="datetimeFigureOut">
              <a:rPr lang="ko-KR" altLang="en-US" smtClean="0"/>
              <a:pPr/>
              <a:t>2022-06-07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9C386B-4784-4080-93BF-55B8687F13E4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="" xmlns:p14="http://schemas.microsoft.com/office/powerpoint/2010/main" val="27880068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353C6-D15F-410C-90A8-B8EFFAAFDC54}" type="datetimeFigureOut">
              <a:rPr lang="ko-KR" altLang="en-US" smtClean="0"/>
              <a:pPr/>
              <a:t>2022-06-07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9C386B-4784-4080-93BF-55B8687F13E4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="" xmlns:p14="http://schemas.microsoft.com/office/powerpoint/2010/main" val="38158577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353C6-D15F-410C-90A8-B8EFFAAFDC54}" type="datetimeFigureOut">
              <a:rPr lang="ko-KR" altLang="en-US" smtClean="0"/>
              <a:pPr/>
              <a:t>2022-06-0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9C386B-4784-4080-93BF-55B8687F13E4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="" xmlns:p14="http://schemas.microsoft.com/office/powerpoint/2010/main" val="40297119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B353C6-D15F-410C-90A8-B8EFFAAFDC54}" type="datetimeFigureOut">
              <a:rPr lang="ko-KR" altLang="en-US" smtClean="0"/>
              <a:pPr/>
              <a:t>2022-06-0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9C386B-4784-4080-93BF-55B8687F13E4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="" xmlns:p14="http://schemas.microsoft.com/office/powerpoint/2010/main" val="26964029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B353C6-D15F-410C-90A8-B8EFFAAFDC54}" type="datetimeFigureOut">
              <a:rPr lang="ko-KR" altLang="en-US" smtClean="0"/>
              <a:pPr/>
              <a:t>2022-06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9C386B-4784-4080-93BF-55B8687F13E4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="" xmlns:p14="http://schemas.microsoft.com/office/powerpoint/2010/main" val="22136513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323528" y="4542219"/>
            <a:ext cx="849694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Times New Roman" pitchFamily="18" charset="0"/>
                <a:cs typeface="Times New Roman" pitchFamily="18" charset="0"/>
              </a:rPr>
              <a:t>Supplementary figure 2. 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FAs of right SLF II is positively correlated with treatment response of negative symptoms at 6 months in patients with schizophrenia. Treatment response of negative symptoms was defined as [(baseline PANSS negative syndrome subscale) – (6-month PANSS negative syndrome subscale)] / (baseline PANSS negative syndrome 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subscale-7) 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× 100. FA, fractional anisotropy; SLF, superior longitudinal fasciculus; PANSS, Positive and Negative Syndrome Scale.</a:t>
            </a:r>
            <a:endParaRPr lang="ko-KR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23728" y="990020"/>
            <a:ext cx="4680520" cy="34577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="" xmlns:p14="http://schemas.microsoft.com/office/powerpoint/2010/main" val="2353169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698</TotalTime>
  <Words>79</Words>
  <Application>Microsoft Office PowerPoint</Application>
  <PresentationFormat>화면 슬라이드 쇼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2" baseType="lpstr">
      <vt:lpstr>Office 테마</vt:lpstr>
      <vt:lpstr>슬라이드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cha</dc:creator>
  <cp:lastModifiedBy>Sra Jung</cp:lastModifiedBy>
  <cp:revision>193</cp:revision>
  <dcterms:created xsi:type="dcterms:W3CDTF">2020-04-21T02:26:32Z</dcterms:created>
  <dcterms:modified xsi:type="dcterms:W3CDTF">2022-06-07T01:05:27Z</dcterms:modified>
</cp:coreProperties>
</file>